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70" r:id="rId2"/>
  </p:sldIdLst>
  <p:sldSz cx="6858000" cy="9144000" type="letter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3CDEF"/>
    <a:srgbClr val="FFCCCC"/>
    <a:srgbClr val="2C11F7"/>
    <a:srgbClr val="CCFFCC"/>
    <a:srgbClr val="CCCCFF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4" autoAdjust="0"/>
    <p:restoredTop sz="94660"/>
  </p:normalViewPr>
  <p:slideViewPr>
    <p:cSldViewPr snapToGrid="0">
      <p:cViewPr varScale="1">
        <p:scale>
          <a:sx n="77" d="100"/>
          <a:sy n="77" d="100"/>
        </p:scale>
        <p:origin x="245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94" d="100"/>
          <a:sy n="94" d="100"/>
        </p:scale>
        <p:origin x="2862" y="8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75F1C848-E130-413A-A8DA-8172A53B0D88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4C6F3B48-2B3A-4C55-BDFB-E1E416627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33520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DCB9EB20-C2EB-4A46-8805-2479D3AB5F2C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3163" y="1200150"/>
            <a:ext cx="24288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3F07D6EC-DFDD-4EE7-ACA8-6578442E63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5759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250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3039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212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359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39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764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123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063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009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114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002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758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54813" y="4521202"/>
            <a:ext cx="541755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FP repression in the profile 2 strains are due to Sir2-mediated silencing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icked one profile 1 strain (control) and three profile 2 strains, where the GFP reporter is inserted into rDNA, telomere, and HML respectively, and carried out a heterozygous Sir2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eletion (Sir2 i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nown to be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aploinsufficien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 GFP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xpression is significantly increased in all the profile 2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train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-value &lt; 0.01 in all three cases)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ut not in th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, confirming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at GFP repression in profile 2 is indeed due to Sir2-mediated silencing. 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440496" y="297899"/>
            <a:ext cx="11107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u_Fig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3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/>
          <a:srcRect l="5533" t="3560" r="77223" b="77281"/>
          <a:stretch/>
        </p:blipFill>
        <p:spPr>
          <a:xfrm>
            <a:off x="997526" y="1438101"/>
            <a:ext cx="2995832" cy="2552007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679170" y="3754051"/>
            <a:ext cx="26010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           2           2           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225553" y="2460462"/>
            <a:ext cx="15439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FP expression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281786" y="3984785"/>
            <a:ext cx="8687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Profile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094313" y="1851615"/>
            <a:ext cx="8687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rDN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566524" y="1450940"/>
            <a:ext cx="8687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elomer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263591" y="2108201"/>
            <a:ext cx="7005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HML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883298" y="1577107"/>
            <a:ext cx="129750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SIR2</a:t>
            </a:r>
            <a:r>
              <a:rPr lang="en-US" sz="12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SIR2</a:t>
            </a:r>
            <a:r>
              <a:rPr lang="en-U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sz="1200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2</a:t>
            </a:r>
            <a:r>
              <a:rPr lang="en-US" sz="1200" b="1" baseline="30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b="1" i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2</a:t>
            </a:r>
            <a:r>
              <a:rPr lang="en-US" sz="1200" b="1" baseline="30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r>
              <a:rPr lang="en-US" sz="12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74142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44</TotalTime>
  <Words>125</Words>
  <Application>Microsoft Office PowerPoint</Application>
  <PresentationFormat>Letter Paper (8.5x11 in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yu Du</dc:creator>
  <cp:lastModifiedBy>lucybai</cp:lastModifiedBy>
  <cp:revision>281</cp:revision>
  <cp:lastPrinted>2016-12-22T22:05:19Z</cp:lastPrinted>
  <dcterms:created xsi:type="dcterms:W3CDTF">2016-06-14T18:48:14Z</dcterms:created>
  <dcterms:modified xsi:type="dcterms:W3CDTF">2017-03-30T15:21:23Z</dcterms:modified>
</cp:coreProperties>
</file>